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9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83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9150" y="6025634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atrina and Zheng (2021) Diabetologia DOI 10.1007/s00125-021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05380-z</a:t>
            </a:r>
            <a:r>
              <a:rPr lang="en-GB" dirty="0"/>
              <a:t>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19150" y="77438"/>
            <a:ext cx="6984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gulation of HIF-1 under non-diabetic and diabetic conditions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C06D7602-76DB-459B-B937-0419C6CD5C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9949" y="477548"/>
            <a:ext cx="6204101" cy="5640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6074713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atrina and Zheng (2021) Diabetologia DOI 10.1007/s00125-021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05380-z</a:t>
            </a:r>
            <a:r>
              <a:rPr lang="en-GB" dirty="0"/>
              <a:t>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8480" y="75401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Impaired responses to hypoxia due to HIF-1 inhibition in diabetes contribute to the development of diabetes and diabetes complications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9AA6AE48-4CFB-4F50-ACF7-69205EAF101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747" y="900392"/>
            <a:ext cx="7078505" cy="5155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4968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</TotalTime>
  <Words>109</Words>
  <Application>Microsoft Office PowerPoint</Application>
  <PresentationFormat>On-screen Show (4:3)</PresentationFormat>
  <Paragraphs>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41</cp:revision>
  <dcterms:created xsi:type="dcterms:W3CDTF">2016-06-15T12:53:43Z</dcterms:created>
  <dcterms:modified xsi:type="dcterms:W3CDTF">2021-01-19T09:34:07Z</dcterms:modified>
</cp:coreProperties>
</file>